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notesMasters/notesMaster1.xml" ContentType="application/vnd.openxmlformats-officedocument.presentationml.notesMaster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07" r:id="rId2"/>
    <p:sldId id="306" r:id="rId3"/>
  </p:sldIdLst>
  <p:sldSz cx="12192000" cy="6858000"/>
  <p:notesSz cx="6858000" cy="91440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71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slide" Target="slides/slide2.xml"/>
   <Relationship Id="rId4" Type="http://schemas.openxmlformats.org/officeDocument/2006/relationships/notesMaster" Target="notesMasters/notesMaster1.xml"/>
   <Relationship Id="rId5" Type="http://schemas.openxmlformats.org/officeDocument/2006/relationships/presProps" Target="presProps.xml"/>
   <Relationship Id="rId6" Type="http://schemas.openxmlformats.org/officeDocument/2006/relationships/viewProps" Target="viewProps.xml"/>
   <Relationship Id="rId7" Type="http://schemas.openxmlformats.org/officeDocument/2006/relationships/theme" Target="theme/theme1.xml"/>
   <Relationship Id="rId8" Type="http://schemas.openxmlformats.org/officeDocument/2006/relationships/tableStyles" Target="tableStyles.xml"/>
</Relationships>
</file>

<file path=ppt/notesMasters/_rels/notesMaster1.xml.rels><?xml version = '1.0' encoding = 'UTF-8' standalone = 'yes'?>
<Relationships xmlns="http://schemas.openxmlformats.org/package/2006/relationships">
   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0A05C050-F66C-4892-941E-9CAEFE974DDD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92BCA241-9BD0-4D86-8B70-A23BDFD1C26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346973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E0E783-AE49-43C8-A4B0-351AA3C3D11E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776244-5D45-4A20-BAB5-7499C4A8B66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2595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9188C2-E227-47A6-856D-8B2C0713C525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7B07F6-A9F0-4E13-B2DF-862148B5A76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8890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FF85E4-A9AA-4828-8B64-76210CC932ED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1D678D-A6CD-4099-9B87-B186368470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803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C5968F-79EE-480B-9DA4-2A3C350185FE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3D5EBC-CC05-43D6-A405-6B686A576B0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743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866660-4879-499A-ADE5-EE84E4AA7C4C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15437F-B030-41F3-9414-C095EDC4F22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8542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235D84-29EF-4DEF-B123-A115C268A0F6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2008AC0-6883-458A-BF2D-0F433892784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1510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25A078-9301-460C-9425-500957A0A83E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B45847-9D15-4D79-9610-289C49FD579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832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59BB98-7B16-49B3-B328-CFCBB3ABCC0B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19286D-72F0-4703-8272-E9E8EFDDECB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262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685B9C-417C-484D-8FA1-96AB639AF7F8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BF692A-1297-4797-9762-3ED20D5364E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3765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3F74A3-91B6-4EDD-AF13-1189393C20D5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E6A3A2-A2F5-406C-9A87-2805D04240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083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DE7159-4FF0-4C7A-9C15-F359FB2D2649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9698DA5-8207-43E6-9B71-8CDA2603F3B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999456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D6747FCE-ABBB-4367-A686-CB30C0E3D4CB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C7FF1C56-4C51-4C41-85D5-77040922DA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</Relationships>
</file>

<file path=ppt/slides/_rels/slide2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image" Target="../media/image1.TIF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64023" y="2315856"/>
            <a:ext cx="11177517" cy="95923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algn="ctr">
              <a:spcBef>
                <a:spcPts val="0"/>
              </a:spcBef>
              <a:spcAft>
                <a:spcPts val="1000"/>
              </a:spcAft>
            </a:pPr>
            <a:r>
              <a:rPr lang="en-US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S5.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ynamics of telomerase expression in human preimplantation embryos. </a:t>
            </a:r>
          </a:p>
          <a:p>
            <a:pPr marL="0" marR="0" algn="ctr">
              <a:spcBef>
                <a:spcPts val="0"/>
              </a:spcBef>
              <a:spcAft>
                <a:spcPts val="1000"/>
              </a:spcAft>
            </a:pP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figure reports fold changes of increased telomerase expression and associated P values in E5.Pre-lineage cells compared with E5.EPI; E5.PE; and E5.TE cells. </a:t>
            </a:r>
            <a:endParaRPr lang="en-US" sz="16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26319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51186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2</TotalTime>
  <Words>39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